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C1D35D-F18D-4A9A-A438-E26D9647081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85973A-5DA0-4F3D-9D19-EB150AADE8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4DE65F-6788-4D89-81FB-530087DE268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1EBE71-4E19-4FE5-8CA3-291E2F85AC6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6A5E4A-CCCF-4F80-B63F-87A754A6EC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95F784-6A33-4C79-9923-2C2D2C1D2E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D95FB5-D5BD-4A01-914B-A7E307C3779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7F5FE4-7095-479D-84B1-03D5C7B035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B883F5-BB74-428C-95BA-0968A3D0F2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381A1F-93F5-4E82-A2B4-A16241A435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AC3394-E43E-47E9-BE8A-DB1C539BD1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BA56FF-2735-4413-8063-138081C690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D37894B-6782-48FC-8E6E-687C3121C31C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6.png"/><Relationship Id="rId6" Type="http://schemas.openxmlformats.org/officeDocument/2006/relationships/image" Target="../media/image7.png"/><Relationship Id="rId7" Type="http://schemas.openxmlformats.org/officeDocument/2006/relationships/image" Target="../media/image8.png"/><Relationship Id="rId8" Type="http://schemas.openxmlformats.org/officeDocument/2006/relationships/image" Target="../media/image9.png"/><Relationship Id="rId9" Type="http://schemas.openxmlformats.org/officeDocument/2006/relationships/image" Target="../media/image10.png"/><Relationship Id="rId10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143000" y="1676520"/>
            <a:ext cx="7848720" cy="28191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1600200" y="4952880"/>
            <a:ext cx="571500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371600" y="4705200"/>
            <a:ext cx="6324480" cy="168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Times New Roman"/>
              </a:rPr>
              <a:t>Additional file 4: (A), the alignment match logo for element Ⅰ: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TOMTOM motif comparison tool was employed to compare element Ⅰ with the known motifs. One known motif , Nkx2-2 (M00485), showed similarity with element Ⅰ. Distance Measure: Pearson; Motif databases: Transfac_Matrix.meme; </a:t>
            </a:r>
            <a:r>
              <a:rPr b="0" i="1" lang="zh-CN" sz="1600" spc="-1" strike="noStrike">
                <a:solidFill>
                  <a:srgbClr val="000000"/>
                </a:solidFill>
                <a:latin typeface="Times New Roman"/>
              </a:rPr>
              <a:t>p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-value: 9.3e-06; Overlap: 10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04920" y="312408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"/>
          <p:cNvGrpSpPr/>
          <p:nvPr/>
        </p:nvGrpSpPr>
        <p:grpSpPr>
          <a:xfrm>
            <a:off x="609480" y="228600"/>
            <a:ext cx="8382240" cy="5083560"/>
            <a:chOff x="609480" y="228600"/>
            <a:chExt cx="8382240" cy="5083560"/>
          </a:xfrm>
        </p:grpSpPr>
        <p:pic>
          <p:nvPicPr>
            <p:cNvPr id="46" name="" descr=""/>
            <p:cNvPicPr/>
            <p:nvPr/>
          </p:nvPicPr>
          <p:blipFill>
            <a:blip r:embed="rId1"/>
            <a:stretch/>
          </p:blipFill>
          <p:spPr>
            <a:xfrm>
              <a:off x="609480" y="228600"/>
              <a:ext cx="2998080" cy="925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" descr=""/>
            <p:cNvPicPr/>
            <p:nvPr/>
          </p:nvPicPr>
          <p:blipFill>
            <a:blip r:embed="rId2"/>
            <a:stretch/>
          </p:blipFill>
          <p:spPr>
            <a:xfrm>
              <a:off x="3757320" y="228600"/>
              <a:ext cx="2698560" cy="925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" descr=""/>
            <p:cNvPicPr/>
            <p:nvPr/>
          </p:nvPicPr>
          <p:blipFill>
            <a:blip r:embed="rId3"/>
            <a:stretch/>
          </p:blipFill>
          <p:spPr>
            <a:xfrm>
              <a:off x="6597000" y="228600"/>
              <a:ext cx="2294640" cy="925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" descr=""/>
            <p:cNvPicPr/>
            <p:nvPr/>
          </p:nvPicPr>
          <p:blipFill>
            <a:blip r:embed="rId4"/>
            <a:stretch/>
          </p:blipFill>
          <p:spPr>
            <a:xfrm>
              <a:off x="679680" y="1926720"/>
              <a:ext cx="2294640" cy="925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" descr=""/>
            <p:cNvPicPr/>
            <p:nvPr/>
          </p:nvPicPr>
          <p:blipFill>
            <a:blip r:embed="rId5"/>
            <a:stretch/>
          </p:blipFill>
          <p:spPr>
            <a:xfrm>
              <a:off x="3215520" y="1981080"/>
              <a:ext cx="2698560" cy="925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" descr=""/>
            <p:cNvPicPr/>
            <p:nvPr/>
          </p:nvPicPr>
          <p:blipFill>
            <a:blip r:embed="rId6"/>
            <a:stretch/>
          </p:blipFill>
          <p:spPr>
            <a:xfrm>
              <a:off x="6174360" y="1992240"/>
              <a:ext cx="2698560" cy="925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" descr=""/>
            <p:cNvPicPr/>
            <p:nvPr/>
          </p:nvPicPr>
          <p:blipFill>
            <a:blip r:embed="rId7"/>
            <a:stretch/>
          </p:blipFill>
          <p:spPr>
            <a:xfrm>
              <a:off x="679680" y="3821040"/>
              <a:ext cx="2887920" cy="926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" descr=""/>
            <p:cNvPicPr/>
            <p:nvPr/>
          </p:nvPicPr>
          <p:blipFill>
            <a:blip r:embed="rId8"/>
            <a:stretch/>
          </p:blipFill>
          <p:spPr>
            <a:xfrm>
              <a:off x="3638160" y="3886560"/>
              <a:ext cx="2294640" cy="925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" descr=""/>
            <p:cNvPicPr/>
            <p:nvPr/>
          </p:nvPicPr>
          <p:blipFill>
            <a:blip r:embed="rId9"/>
            <a:stretch/>
          </p:blipFill>
          <p:spPr>
            <a:xfrm>
              <a:off x="6033240" y="3821040"/>
              <a:ext cx="2958480" cy="999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"/>
            <p:cNvSpPr/>
            <p:nvPr/>
          </p:nvSpPr>
          <p:spPr>
            <a:xfrm>
              <a:off x="2018160" y="1285920"/>
              <a:ext cx="281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4976640" y="1285920"/>
              <a:ext cx="352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7723800" y="1273320"/>
              <a:ext cx="422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806840" y="3049560"/>
              <a:ext cx="424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4765320" y="3049560"/>
              <a:ext cx="422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7512480" y="3037320"/>
              <a:ext cx="422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877400" y="4943880"/>
              <a:ext cx="353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4835880" y="4943880"/>
              <a:ext cx="352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7583040" y="4932000"/>
              <a:ext cx="422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4" name=""/>
          <p:cNvSpPr/>
          <p:nvPr/>
        </p:nvSpPr>
        <p:spPr>
          <a:xfrm>
            <a:off x="990720" y="5213520"/>
            <a:ext cx="7086600" cy="164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(B), the match logo for element Ⅲ: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TOMTOM motif comparison tool was employed to compare element Ⅲ with the known motifs. Nine known motifs showed similarity with element Ⅲ. Distance Measure: Pearson; Motif databases: Transfac_Matrix.meme; </a:t>
            </a:r>
            <a:r>
              <a:rPr b="0" i="1" lang="zh-CN" sz="12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-value&lt; 0.002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A: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Hb (M00022) ; Overlap: 10.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B: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BR-C Z1 (M00091); Overlap: 15.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C: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CDX (M00991); Overlap: 16.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D: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TCF (M01092); Overlap: 14.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E: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BR-C Z2 (M00092); Overlap: 15.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F: 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Nkx6-1 (M00424); Overlap: 13.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G: 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FOXP1 (M00987); Overlap: 10.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 H: 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HNF3 (M01012); Overlap: 18.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 I : 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PLZF (M01075); Overlap: 12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0" y="289548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微软用户</cp:lastModifiedBy>
  <dcterms:modified xsi:type="dcterms:W3CDTF">2010-03-05T02:26:37Z</dcterms:modified>
  <cp:revision>12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